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1369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5072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8393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5352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6627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1804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2519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5553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2943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9905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7946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1777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307773" y="43545"/>
            <a:ext cx="838635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5 Table: 51  Novel </a:t>
            </a:r>
            <a:r>
              <a:rPr lang="en-US" b="1" i="1" dirty="0" smtClean="0">
                <a:latin typeface="Times New Roman" pitchFamily="18" charset="0"/>
                <a:cs typeface="Times New Roman" pitchFamily="18" charset="0"/>
              </a:rPr>
              <a:t>DMD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  point mutations  identified in our cohort of 961 suspected DMD patients with LOVD submission numbers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1499307"/>
              </p:ext>
            </p:extLst>
          </p:nvPr>
        </p:nvGraphicFramePr>
        <p:xfrm>
          <a:off x="156755" y="766426"/>
          <a:ext cx="5778532" cy="596925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55707">
                  <a:extLst>
                    <a:ext uri="{9D8B030D-6E8A-4147-A177-3AD203B41FA5}">
                      <a16:colId xmlns:a16="http://schemas.microsoft.com/office/drawing/2014/main" val="3804666312"/>
                    </a:ext>
                  </a:extLst>
                </a:gridCol>
                <a:gridCol w="988115">
                  <a:extLst>
                    <a:ext uri="{9D8B030D-6E8A-4147-A177-3AD203B41FA5}">
                      <a16:colId xmlns:a16="http://schemas.microsoft.com/office/drawing/2014/main" val="2882990545"/>
                    </a:ext>
                  </a:extLst>
                </a:gridCol>
                <a:gridCol w="1828236">
                  <a:extLst>
                    <a:ext uri="{9D8B030D-6E8A-4147-A177-3AD203B41FA5}">
                      <a16:colId xmlns:a16="http://schemas.microsoft.com/office/drawing/2014/main" val="640181418"/>
                    </a:ext>
                  </a:extLst>
                </a:gridCol>
                <a:gridCol w="848825">
                  <a:extLst>
                    <a:ext uri="{9D8B030D-6E8A-4147-A177-3AD203B41FA5}">
                      <a16:colId xmlns:a16="http://schemas.microsoft.com/office/drawing/2014/main" val="2363353438"/>
                    </a:ext>
                  </a:extLst>
                </a:gridCol>
                <a:gridCol w="957649">
                  <a:extLst>
                    <a:ext uri="{9D8B030D-6E8A-4147-A177-3AD203B41FA5}">
                      <a16:colId xmlns:a16="http://schemas.microsoft.com/office/drawing/2014/main" val="1025386171"/>
                    </a:ext>
                  </a:extLst>
                </a:gridCol>
              </a:tblGrid>
              <a:tr h="45702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 I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144" marR="6144" marT="6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144" marR="6144" marT="6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tation</a:t>
                      </a:r>
                      <a:endParaRPr lang="en-IN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144" marR="6144" marT="6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 of patients</a:t>
                      </a:r>
                    </a:p>
                  </a:txBody>
                  <a:tcPr marL="6144" marR="6144" marT="6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ividual ID  LOVD</a:t>
                      </a:r>
                    </a:p>
                  </a:txBody>
                  <a:tcPr marL="6144" marR="6144" marT="6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98881"/>
                  </a:ext>
                </a:extLst>
              </a:tr>
              <a:tr h="175931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428/B-482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n 18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2293-2A&gt;C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42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9449499"/>
                  </a:ext>
                </a:extLst>
              </a:tr>
              <a:tr h="225323"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45/DBI-149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30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4180delG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43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6250953"/>
                  </a:ext>
                </a:extLst>
              </a:tr>
              <a:tr h="255344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54/DBI-1710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61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9155_9156delTT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44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8343111"/>
                  </a:ext>
                </a:extLst>
              </a:tr>
              <a:tr h="17593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301/B-36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35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4948G&gt;T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45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1580735"/>
                  </a:ext>
                </a:extLst>
              </a:tr>
              <a:tr h="22532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488/B-553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68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9897_9898delC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4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5038847"/>
                  </a:ext>
                </a:extLst>
              </a:tr>
              <a:tr h="17593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513/B-590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55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8082C&gt;G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47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8022530"/>
                  </a:ext>
                </a:extLst>
              </a:tr>
              <a:tr h="17593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605/B-715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12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1363C&gt;G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48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3109687"/>
                  </a:ext>
                </a:extLst>
              </a:tr>
              <a:tr h="17706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668/B-79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48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7032_7033insC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49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6281219"/>
                  </a:ext>
                </a:extLst>
              </a:tr>
              <a:tr h="25534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0/DBI-986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3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5140_5141delG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50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5979173"/>
                  </a:ext>
                </a:extLst>
              </a:tr>
              <a:tr h="17593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42/B-40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28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3836delA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51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5339726"/>
                  </a:ext>
                </a:extLst>
              </a:tr>
              <a:tr h="182797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508/B-583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n 44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6438+1G&gt;C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52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8035436"/>
                  </a:ext>
                </a:extLst>
              </a:tr>
              <a:tr h="224914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84/DBI-1071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n 44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6438+2T&gt;G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53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3073854"/>
                  </a:ext>
                </a:extLst>
              </a:tr>
              <a:tr h="237105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964/DBI-830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7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582del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54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723095"/>
                  </a:ext>
                </a:extLst>
              </a:tr>
              <a:tr h="25534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965/DBI-83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50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7224dupT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55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3453375"/>
                  </a:ext>
                </a:extLst>
              </a:tr>
              <a:tr h="25534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691/DBI-599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2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2642C&gt;G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5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2914333"/>
                  </a:ext>
                </a:extLst>
              </a:tr>
              <a:tr h="227985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44/DBI-1558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45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6611dup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57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9854166"/>
                  </a:ext>
                </a:extLst>
              </a:tr>
              <a:tr h="17593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90/B-98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51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7348delG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58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9868856"/>
                  </a:ext>
                </a:extLst>
              </a:tr>
              <a:tr h="17593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67/B-172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71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10228G&gt;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59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2238298"/>
                  </a:ext>
                </a:extLst>
              </a:tr>
              <a:tr h="17593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228/B-250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28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3796delG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6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6110910"/>
                  </a:ext>
                </a:extLst>
              </a:tr>
              <a:tr h="17593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273/B-320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48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6979G&gt;T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62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2271409"/>
                  </a:ext>
                </a:extLst>
              </a:tr>
              <a:tr h="24798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319/B-385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n 70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10224-1dupG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63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3070593"/>
                  </a:ext>
                </a:extLst>
              </a:tr>
              <a:tr h="17593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507/B-58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32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4350dup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64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6453195"/>
                  </a:ext>
                </a:extLst>
              </a:tr>
              <a:tr h="258512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662/B-79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n 10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1150-2_1150-1delAG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65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3427060"/>
                  </a:ext>
                </a:extLst>
              </a:tr>
              <a:tr h="17593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734/DBI-643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n 4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265-2A&gt;T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6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6626260"/>
                  </a:ext>
                </a:extLst>
              </a:tr>
              <a:tr h="218866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925/DBI-797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n 69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10086+1G&gt;C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67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5360373"/>
                  </a:ext>
                </a:extLst>
              </a:tr>
              <a:tr h="329754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940/DBI-813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24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3170_3173delTAC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60" marR="5560" marT="556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68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969" marR="7969" marT="796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6618283"/>
                  </a:ext>
                </a:extLst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1425188"/>
              </p:ext>
            </p:extLst>
          </p:nvPr>
        </p:nvGraphicFramePr>
        <p:xfrm>
          <a:off x="6500949" y="766426"/>
          <a:ext cx="5245330" cy="59487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49066">
                  <a:extLst>
                    <a:ext uri="{9D8B030D-6E8A-4147-A177-3AD203B41FA5}">
                      <a16:colId xmlns:a16="http://schemas.microsoft.com/office/drawing/2014/main" val="2707287326"/>
                    </a:ext>
                  </a:extLst>
                </a:gridCol>
                <a:gridCol w="988739">
                  <a:extLst>
                    <a:ext uri="{9D8B030D-6E8A-4147-A177-3AD203B41FA5}">
                      <a16:colId xmlns:a16="http://schemas.microsoft.com/office/drawing/2014/main" val="2847001638"/>
                    </a:ext>
                  </a:extLst>
                </a:gridCol>
                <a:gridCol w="1280160">
                  <a:extLst>
                    <a:ext uri="{9D8B030D-6E8A-4147-A177-3AD203B41FA5}">
                      <a16:colId xmlns:a16="http://schemas.microsoft.com/office/drawing/2014/main" val="3646197342"/>
                    </a:ext>
                  </a:extLst>
                </a:gridCol>
                <a:gridCol w="754315">
                  <a:extLst>
                    <a:ext uri="{9D8B030D-6E8A-4147-A177-3AD203B41FA5}">
                      <a16:colId xmlns:a16="http://schemas.microsoft.com/office/drawing/2014/main" val="2396212987"/>
                    </a:ext>
                  </a:extLst>
                </a:gridCol>
                <a:gridCol w="1173050">
                  <a:extLst>
                    <a:ext uri="{9D8B030D-6E8A-4147-A177-3AD203B41FA5}">
                      <a16:colId xmlns:a16="http://schemas.microsoft.com/office/drawing/2014/main" val="2936019159"/>
                    </a:ext>
                  </a:extLst>
                </a:gridCol>
              </a:tblGrid>
              <a:tr h="3495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b I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144" marR="6144" marT="6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144" marR="6144" marT="6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tation</a:t>
                      </a:r>
                      <a:endParaRPr lang="en-IN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144" marR="6144" marT="6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 of patients</a:t>
                      </a:r>
                    </a:p>
                  </a:txBody>
                  <a:tcPr marL="6144" marR="6144" marT="6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ividual ID  LOVD</a:t>
                      </a:r>
                    </a:p>
                  </a:txBody>
                  <a:tcPr marL="6144" marR="6144" marT="614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4151392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945/DBI-814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35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4847delC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469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8468477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03/DBI-934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53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7858delA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00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39267210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19/DBI-1100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366dupT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01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6047089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36/DBI-1115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3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4236A&gt;C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02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3283632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07/DBI-1173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29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3923C&gt;G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03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5916369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1/DBI-121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418delC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04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6679261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84/DBI-129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44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6372del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05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8756527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54/DBI-1357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n 49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7201-1G&gt;C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06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1922545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92/DBI-1384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3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5028del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07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0059817"/>
                  </a:ext>
                </a:extLst>
              </a:tr>
              <a:tr h="36738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24/DBI-148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45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6497_6498insT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08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9316494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25/DBI-1482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n 32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4518+2T&gt;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09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2043286"/>
                  </a:ext>
                </a:extLst>
              </a:tr>
              <a:tr h="292197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17/DBI-1539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48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7072_7073dupA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10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5169578"/>
                  </a:ext>
                </a:extLst>
              </a:tr>
              <a:tr h="36738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33/DBI-1552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16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1900_1903dupAAGT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1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864201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40/DBI-1557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44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6407G&gt;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12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0532040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9/DBI-159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32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4350dup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13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8321998"/>
                  </a:ext>
                </a:extLst>
              </a:tr>
              <a:tr h="27175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78/DBI-1653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35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4959_4960delCA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14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2736715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970/DBI-83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29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3927del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15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49765472"/>
                  </a:ext>
                </a:extLst>
              </a:tr>
              <a:tr h="310847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51/DBI-1496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37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5227_5228delinsTG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32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2282938"/>
                  </a:ext>
                </a:extLst>
              </a:tr>
              <a:tr h="308416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67/DBI-1725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n 64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9361+1G&gt;C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16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4966488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84/B-87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18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2273A&gt;C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17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430467"/>
                  </a:ext>
                </a:extLst>
              </a:tr>
              <a:tr h="291531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0/DBI-940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32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4471_4472delAA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20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5666250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63/B-168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44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6428G&gt;A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22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3839378"/>
                  </a:ext>
                </a:extLst>
              </a:tr>
              <a:tr h="242767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7/DBI-1015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on 10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1149+1G&gt;A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24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1055999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47/DBI-1278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18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2251C&gt;T</a:t>
                      </a:r>
                      <a:endParaRPr lang="en-IN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27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0935400"/>
                  </a:ext>
                </a:extLst>
              </a:tr>
              <a:tr h="185113"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54/DBI-1500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2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.2667A&gt;T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047" marR="6047" marT="604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69529</a:t>
                      </a:r>
                      <a:endParaRPr lang="en-IN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288" marR="8288" marT="82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7055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9917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7</Words>
  <Application>Microsoft Office PowerPoint</Application>
  <PresentationFormat>Widescreen</PresentationFormat>
  <Paragraphs>2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dcrc</dc:creator>
  <cp:lastModifiedBy>mdcrc</cp:lastModifiedBy>
  <cp:revision>8</cp:revision>
  <dcterms:created xsi:type="dcterms:W3CDTF">2020-01-14T07:41:46Z</dcterms:created>
  <dcterms:modified xsi:type="dcterms:W3CDTF">2020-01-14T07:48:19Z</dcterms:modified>
</cp:coreProperties>
</file>